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29"/>
  </p:normalViewPr>
  <p:slideViewPr>
    <p:cSldViewPr snapToGrid="0" snapToObjects="1">
      <p:cViewPr varScale="1">
        <p:scale>
          <a:sx n="115" d="100"/>
          <a:sy n="115" d="100"/>
        </p:scale>
        <p:origin x="47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9ECDFCD-A201-524F-8A50-89AD091BE4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2FCD965-1201-F84F-81AD-F3ECCFC6C9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B8D5224-2F5B-344D-B445-7386E47FD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130102A-3026-EA41-9750-0A09B7F44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FEDF68A-5CDA-0642-BCD5-377D915E1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5310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4F41D4-9A23-EA4C-A466-0E685AF9D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9D33345-F1EF-0F46-8B82-924747F404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36C8223-D787-9F4F-81E2-59D8BC797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613E4D8-ACFC-3B43-903A-959C29343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7032B4F-0058-8F46-8C24-9DB03FE24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715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2BF99C4-385B-2847-BBBC-5E9830E729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7384B77-7986-7944-8EDB-4FB6DD5134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23918A-ED70-0447-A57A-E634C6834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CEFFC4E-CFA4-984E-8618-E173E7DF2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BA11BFA-E5AE-6547-9B03-8DCA9FBEB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3343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D8B46C-A035-1846-88A9-259D95C327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6FBB3A1-CF88-5845-9660-10BA28132C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2C4265-6CE9-C745-9759-81E1758A8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AD5EBE-85CC-FD40-B07A-1E7F5CAEB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93F7E50-ECCC-8648-A1CF-601629149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579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D7D15B-486C-A543-A565-A19540875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47182B3-0977-7142-AA17-C9EC1CC555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CBF5B66-12F2-7A40-897F-C2B2FD56F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E9B93F4-F15C-0543-8017-24BBE1DEF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1CEA59F-3701-A74E-8B90-115F87C27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1906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811267-9DE3-D841-B4AF-5CC077721C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73CACD5-6BE8-C84D-A372-E4F5C3DFD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D6689C5-6CA1-3749-8069-59526E3548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5026D5A-C337-754C-96F8-7D9130F33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5D85E4B-0215-8B43-8E6D-D1105BEBB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397ADE4-D19D-2641-BECD-99240316B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1451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696CCC-99CD-C744-A581-6DFC5D2C4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8C8134-E317-C340-9FCE-E19A9FF663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2639F8E-14E8-C044-978C-D97A6AFF59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BBC1507-0A1E-0F41-94AB-9E9675A19B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DFD60F0-7D2B-ED43-A786-40A3C17ABF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1E0C2E3-1700-2449-82F3-62C91547C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5235A77-1401-874B-A31E-F6626B5E4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D495E6A-BE6D-DB47-9B6B-57FC10BCC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6947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0D69B7A-43AE-9748-A08E-636F7BEC3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85F16B8-7DFC-4940-8B33-2BB68FC26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E014109-219F-F544-AC47-1B4265B9B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5EEECD9-5691-094A-B3DE-6243A8B54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9526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1D990A2-4E11-BC41-9A8D-958D7D3AF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203362C-CA02-8643-AD80-4C8F05EBB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D342DCA-E287-C04E-A9AC-5194AF039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1872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181AEE3-A819-5A48-8DB9-A29E65F34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8722E12-C442-544F-A731-CC74EF615A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53D02BB-972A-A743-9BFD-1F15044D24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3D2DA54-B2DC-444C-AA6B-8972483BA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4F7DC48-1C8C-7D42-BD41-E0D9FBB63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DAF6E9A-0ABF-9E42-98CD-CF4483693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4344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8F26325-2FF7-A64A-8466-5A330D1729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5B0E1A2-CBCD-CC4E-9C8C-6A00BBF9B3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3F073F5-3283-A749-9F8D-EE6B6A7116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63EFE3D-AE93-FF4C-A226-B03812A53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863E763-645D-4447-8E35-58A0D7F3B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F36BB57-3822-5E49-ACB7-CE0AF1E28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9291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6953B9C-F861-754C-958F-357CCAB32E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69B7787-F88A-DA4F-9996-D8F4D2B8BE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5B5EF94-9749-7745-989B-D769735623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94CE23-FCB4-1B4A-B3B3-D39B2043B98F}" type="datetimeFigureOut">
              <a:rPr lang="fr-FR" smtClean="0"/>
              <a:t>05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09CB50-573C-AB4E-A9A8-D5900F0175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2DBA8F6-5009-EB4A-86CE-E9E69B4795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C0C89-DB24-8B47-8CE4-F05DF9B269A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2339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à coins arrondis 4">
            <a:extLst>
              <a:ext uri="{FF2B5EF4-FFF2-40B4-BE49-F238E27FC236}">
                <a16:creationId xmlns:a16="http://schemas.microsoft.com/office/drawing/2014/main" id="{C2DE3B15-AD52-9F46-92DC-8DDD50F48155}"/>
              </a:ext>
            </a:extLst>
          </p:cNvPr>
          <p:cNvSpPr/>
          <p:nvPr/>
        </p:nvSpPr>
        <p:spPr>
          <a:xfrm>
            <a:off x="6359794" y="1538374"/>
            <a:ext cx="3229999" cy="187150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Rectangle à coins arrondis 5">
            <a:extLst>
              <a:ext uri="{FF2B5EF4-FFF2-40B4-BE49-F238E27FC236}">
                <a16:creationId xmlns:a16="http://schemas.microsoft.com/office/drawing/2014/main" id="{2797F214-6E14-464F-8FED-9C5B8CC88AA1}"/>
              </a:ext>
            </a:extLst>
          </p:cNvPr>
          <p:cNvSpPr/>
          <p:nvPr/>
        </p:nvSpPr>
        <p:spPr>
          <a:xfrm>
            <a:off x="3170937" y="4919377"/>
            <a:ext cx="1823644" cy="902209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Rectangle à coins arrondis 6">
            <a:extLst>
              <a:ext uri="{FF2B5EF4-FFF2-40B4-BE49-F238E27FC236}">
                <a16:creationId xmlns:a16="http://schemas.microsoft.com/office/drawing/2014/main" id="{9B3EB794-D0B7-F940-8A2C-4A4CBD817922}"/>
              </a:ext>
            </a:extLst>
          </p:cNvPr>
          <p:cNvSpPr/>
          <p:nvPr/>
        </p:nvSpPr>
        <p:spPr>
          <a:xfrm>
            <a:off x="4943246" y="3812439"/>
            <a:ext cx="1823644" cy="726676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94D3DB0-4550-774D-980C-9C8ADE1AFF80}"/>
              </a:ext>
            </a:extLst>
          </p:cNvPr>
          <p:cNvSpPr txBox="1"/>
          <p:nvPr/>
        </p:nvSpPr>
        <p:spPr>
          <a:xfrm>
            <a:off x="6824195" y="1546485"/>
            <a:ext cx="1601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Exclusion N=12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E6B99039-A7EF-EF41-8C8B-23289E89557F}"/>
              </a:ext>
            </a:extLst>
          </p:cNvPr>
          <p:cNvSpPr txBox="1"/>
          <p:nvPr/>
        </p:nvSpPr>
        <p:spPr>
          <a:xfrm>
            <a:off x="3017807" y="5073061"/>
            <a:ext cx="2074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Saline</a:t>
            </a:r>
          </a:p>
          <a:p>
            <a:pPr algn="ctr"/>
            <a:r>
              <a:rPr lang="fr-FR" dirty="0"/>
              <a:t>N=21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D7300EFD-AF43-D14D-9566-271DCA020E29}"/>
              </a:ext>
            </a:extLst>
          </p:cNvPr>
          <p:cNvSpPr txBox="1"/>
          <p:nvPr/>
        </p:nvSpPr>
        <p:spPr>
          <a:xfrm>
            <a:off x="5506292" y="3992010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N=50</a:t>
            </a:r>
          </a:p>
        </p:txBody>
      </p: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49925A71-152A-6B46-B4F1-0BF39358E542}"/>
              </a:ext>
            </a:extLst>
          </p:cNvPr>
          <p:cNvCxnSpPr>
            <a:cxnSpLocks/>
          </p:cNvCxnSpPr>
          <p:nvPr/>
        </p:nvCxnSpPr>
        <p:spPr>
          <a:xfrm>
            <a:off x="5847892" y="1432757"/>
            <a:ext cx="1717" cy="2336631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11EF0CAB-71F8-4E42-A2FD-FDF7B1E6CE64}"/>
              </a:ext>
            </a:extLst>
          </p:cNvPr>
          <p:cNvCxnSpPr/>
          <p:nvPr/>
        </p:nvCxnSpPr>
        <p:spPr>
          <a:xfrm>
            <a:off x="5849609" y="2443611"/>
            <a:ext cx="499331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Rectangle à coins arrondis 13">
            <a:extLst>
              <a:ext uri="{FF2B5EF4-FFF2-40B4-BE49-F238E27FC236}">
                <a16:creationId xmlns:a16="http://schemas.microsoft.com/office/drawing/2014/main" id="{C6EE1B04-6833-464C-BD2D-ADC63E574C0B}"/>
              </a:ext>
            </a:extLst>
          </p:cNvPr>
          <p:cNvSpPr/>
          <p:nvPr/>
        </p:nvSpPr>
        <p:spPr>
          <a:xfrm>
            <a:off x="3017807" y="347549"/>
            <a:ext cx="5818722" cy="1059443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5065948-E16B-2F4C-8328-7AA3C323AC44}"/>
              </a:ext>
            </a:extLst>
          </p:cNvPr>
          <p:cNvSpPr txBox="1"/>
          <p:nvPr/>
        </p:nvSpPr>
        <p:spPr>
          <a:xfrm>
            <a:off x="3797742" y="423013"/>
            <a:ext cx="430425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Patients </a:t>
            </a:r>
            <a:r>
              <a:rPr lang="fr-FR" dirty="0" err="1"/>
              <a:t>admitted</a:t>
            </a:r>
            <a:r>
              <a:rPr lang="fr-FR" dirty="0"/>
              <a:t> in ICU for sepsis +/- </a:t>
            </a:r>
            <a:r>
              <a:rPr lang="fr-FR" dirty="0" err="1"/>
              <a:t>shock</a:t>
            </a:r>
            <a:endParaRPr lang="fr-FR" dirty="0"/>
          </a:p>
          <a:p>
            <a:pPr algn="ctr"/>
            <a:r>
              <a:rPr lang="fr-FR" dirty="0"/>
              <a:t>And CRT &gt; 3 seconds </a:t>
            </a:r>
            <a:r>
              <a:rPr lang="fr-FR" dirty="0" err="1"/>
              <a:t>after</a:t>
            </a:r>
            <a:r>
              <a:rPr lang="fr-FR" dirty="0"/>
              <a:t> </a:t>
            </a:r>
            <a:r>
              <a:rPr lang="fr-FR" dirty="0" err="1"/>
              <a:t>resuscitation</a:t>
            </a:r>
            <a:endParaRPr lang="fr-FR" dirty="0"/>
          </a:p>
          <a:p>
            <a:pPr algn="ctr"/>
            <a:r>
              <a:rPr lang="fr-FR" dirty="0"/>
              <a:t>N=62</a:t>
            </a:r>
          </a:p>
        </p:txBody>
      </p:sp>
      <p:sp>
        <p:nvSpPr>
          <p:cNvPr id="17" name="Rectangle à coins arrondis 16">
            <a:extLst>
              <a:ext uri="{FF2B5EF4-FFF2-40B4-BE49-F238E27FC236}">
                <a16:creationId xmlns:a16="http://schemas.microsoft.com/office/drawing/2014/main" id="{CA633B05-9510-CC40-9D61-BC097A2D2F4D}"/>
              </a:ext>
            </a:extLst>
          </p:cNvPr>
          <p:cNvSpPr/>
          <p:nvPr/>
        </p:nvSpPr>
        <p:spPr>
          <a:xfrm>
            <a:off x="6734239" y="4913690"/>
            <a:ext cx="1823644" cy="907895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FDF93BEA-7DEF-6F4F-BB5E-4DFD941D37E9}"/>
              </a:ext>
            </a:extLst>
          </p:cNvPr>
          <p:cNvSpPr txBox="1"/>
          <p:nvPr/>
        </p:nvSpPr>
        <p:spPr>
          <a:xfrm>
            <a:off x="6552409" y="5067374"/>
            <a:ext cx="2074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/>
              <a:t>Albumin</a:t>
            </a:r>
            <a:endParaRPr lang="fr-FR" dirty="0"/>
          </a:p>
          <a:p>
            <a:pPr algn="ctr"/>
            <a:r>
              <a:rPr lang="fr-FR" dirty="0"/>
              <a:t>N=29</a:t>
            </a:r>
          </a:p>
        </p:txBody>
      </p: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72001084-A7E1-B149-B2FB-0FAA6053FDC5}"/>
              </a:ext>
            </a:extLst>
          </p:cNvPr>
          <p:cNvCxnSpPr/>
          <p:nvPr/>
        </p:nvCxnSpPr>
        <p:spPr>
          <a:xfrm flipH="1">
            <a:off x="5044806" y="4567819"/>
            <a:ext cx="803087" cy="38026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avec flèche 20">
            <a:extLst>
              <a:ext uri="{FF2B5EF4-FFF2-40B4-BE49-F238E27FC236}">
                <a16:creationId xmlns:a16="http://schemas.microsoft.com/office/drawing/2014/main" id="{0A48E6F7-9384-A94D-80CA-F3EE77359D24}"/>
              </a:ext>
            </a:extLst>
          </p:cNvPr>
          <p:cNvCxnSpPr/>
          <p:nvPr/>
        </p:nvCxnSpPr>
        <p:spPr>
          <a:xfrm>
            <a:off x="5931152" y="4567819"/>
            <a:ext cx="803087" cy="38026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ZoneTexte 23">
            <a:extLst>
              <a:ext uri="{FF2B5EF4-FFF2-40B4-BE49-F238E27FC236}">
                <a16:creationId xmlns:a16="http://schemas.microsoft.com/office/drawing/2014/main" id="{1929B41E-00E2-D243-B822-3E54B92813AC}"/>
              </a:ext>
            </a:extLst>
          </p:cNvPr>
          <p:cNvSpPr txBox="1"/>
          <p:nvPr/>
        </p:nvSpPr>
        <p:spPr>
          <a:xfrm>
            <a:off x="6444829" y="1817632"/>
            <a:ext cx="1020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COVID-19 +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AC9525F0-C48A-734D-8F94-54A86EE5CD4A}"/>
              </a:ext>
            </a:extLst>
          </p:cNvPr>
          <p:cNvSpPr txBox="1"/>
          <p:nvPr/>
        </p:nvSpPr>
        <p:spPr>
          <a:xfrm>
            <a:off x="6433105" y="2687005"/>
            <a:ext cx="1598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Inclusion </a:t>
            </a:r>
            <a:r>
              <a:rPr lang="fr-FR" sz="1400" dirty="0" err="1"/>
              <a:t>before</a:t>
            </a:r>
            <a:r>
              <a:rPr lang="fr-FR" sz="1400" dirty="0"/>
              <a:t> H6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6D7AD735-34F2-CD48-8BDB-0DB13ADC004A}"/>
              </a:ext>
            </a:extLst>
          </p:cNvPr>
          <p:cNvSpPr txBox="1"/>
          <p:nvPr/>
        </p:nvSpPr>
        <p:spPr>
          <a:xfrm>
            <a:off x="6428863" y="2976796"/>
            <a:ext cx="19934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Hemodynamic</a:t>
            </a:r>
            <a:r>
              <a:rPr lang="fr-FR" sz="1400" dirty="0"/>
              <a:t> </a:t>
            </a:r>
            <a:r>
              <a:rPr lang="fr-FR" sz="1400" dirty="0" err="1"/>
              <a:t>instability</a:t>
            </a:r>
            <a:endParaRPr lang="fr-FR" sz="1400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4177699B-3944-7E4F-AF64-07FFECD7C6EC}"/>
              </a:ext>
            </a:extLst>
          </p:cNvPr>
          <p:cNvSpPr txBox="1"/>
          <p:nvPr/>
        </p:nvSpPr>
        <p:spPr>
          <a:xfrm>
            <a:off x="6455629" y="2397214"/>
            <a:ext cx="10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uratorship</a:t>
            </a:r>
            <a:r>
              <a:rPr lang="fr-FR" sz="1400" dirty="0"/>
              <a:t> 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C3DD8736-6F62-4D4A-AEF2-837D66469622}"/>
              </a:ext>
            </a:extLst>
          </p:cNvPr>
          <p:cNvSpPr txBox="1"/>
          <p:nvPr/>
        </p:nvSpPr>
        <p:spPr>
          <a:xfrm>
            <a:off x="6428863" y="2107423"/>
            <a:ext cx="3160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No affiliation to a social </a:t>
            </a:r>
            <a:r>
              <a:rPr lang="fr-FR" sz="1400" dirty="0" err="1"/>
              <a:t>security</a:t>
            </a:r>
            <a:r>
              <a:rPr lang="fr-FR" sz="1400" dirty="0"/>
              <a:t> </a:t>
            </a:r>
            <a:r>
              <a:rPr lang="fr-FR" sz="1400" dirty="0" err="1"/>
              <a:t>regimen</a:t>
            </a:r>
            <a:endParaRPr lang="fr-FR" sz="1400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D1B39B31-07D7-044B-B51C-F1CD7AD2CDDC}"/>
              </a:ext>
            </a:extLst>
          </p:cNvPr>
          <p:cNvSpPr txBox="1"/>
          <p:nvPr/>
        </p:nvSpPr>
        <p:spPr>
          <a:xfrm>
            <a:off x="245326" y="6311591"/>
            <a:ext cx="2797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/>
              <a:t>Supplementary</a:t>
            </a:r>
            <a:r>
              <a:rPr lang="fr-FR" sz="1400" b="1" dirty="0"/>
              <a:t> figure 1. flow chart</a:t>
            </a:r>
          </a:p>
        </p:txBody>
      </p:sp>
    </p:spTree>
    <p:extLst>
      <p:ext uri="{BB962C8B-B14F-4D97-AF65-F5344CB8AC3E}">
        <p14:creationId xmlns:p14="http://schemas.microsoft.com/office/powerpoint/2010/main" val="506235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57424054-90B9-C040-9F75-27061AA90AD7}"/>
              </a:ext>
            </a:extLst>
          </p:cNvPr>
          <p:cNvSpPr txBox="1"/>
          <p:nvPr/>
        </p:nvSpPr>
        <p:spPr>
          <a:xfrm>
            <a:off x="695710" y="5910147"/>
            <a:ext cx="110799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upplementary</a:t>
            </a:r>
            <a:r>
              <a:rPr lang="fr-FR" sz="1400" b="1" dirty="0"/>
              <a:t> figure 2</a:t>
            </a:r>
            <a:r>
              <a:rPr lang="fr-FR" sz="1400" dirty="0"/>
              <a:t>. </a:t>
            </a:r>
            <a:r>
              <a:rPr lang="fr-FR" sz="1400" dirty="0" err="1"/>
              <a:t>Correlation</a:t>
            </a:r>
            <a:r>
              <a:rPr lang="fr-FR" sz="1400" dirty="0"/>
              <a:t> </a:t>
            </a:r>
            <a:r>
              <a:rPr lang="fr-FR" sz="1400" dirty="0" err="1"/>
              <a:t>between</a:t>
            </a:r>
            <a:r>
              <a:rPr lang="fr-FR" sz="1400" dirty="0"/>
              <a:t> variations of </a:t>
            </a:r>
            <a:r>
              <a:rPr lang="fr-FR" sz="1400" dirty="0" err="1"/>
              <a:t>cardiac</a:t>
            </a:r>
            <a:r>
              <a:rPr lang="fr-FR" sz="1400" dirty="0"/>
              <a:t> index (H1-H0) and variations of </a:t>
            </a:r>
            <a:r>
              <a:rPr lang="fr-FR" sz="1400" dirty="0" err="1"/>
              <a:t>fingertip</a:t>
            </a:r>
            <a:r>
              <a:rPr lang="fr-FR" sz="1400" dirty="0"/>
              <a:t> CRT (H1-H0) in the saline (white </a:t>
            </a:r>
            <a:r>
              <a:rPr lang="fr-FR" sz="1400" dirty="0" err="1"/>
              <a:t>circles</a:t>
            </a:r>
            <a:r>
              <a:rPr lang="fr-FR" sz="1400" dirty="0"/>
              <a:t>) and </a:t>
            </a:r>
            <a:r>
              <a:rPr lang="fr-FR" sz="1400" dirty="0" err="1"/>
              <a:t>albumin</a:t>
            </a:r>
            <a:r>
              <a:rPr lang="fr-FR" sz="1400" dirty="0"/>
              <a:t> group (</a:t>
            </a:r>
            <a:r>
              <a:rPr lang="fr-FR" sz="1400" dirty="0" err="1"/>
              <a:t>Red</a:t>
            </a:r>
            <a:r>
              <a:rPr lang="fr-FR" sz="1400" dirty="0"/>
              <a:t> </a:t>
            </a:r>
            <a:r>
              <a:rPr lang="fr-FR" sz="1400" dirty="0" err="1"/>
              <a:t>circle</a:t>
            </a:r>
            <a:r>
              <a:rPr lang="fr-FR" sz="1400" dirty="0"/>
              <a:t>). Pearson test.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1FDD1AE8-2A17-014B-8129-B69828EFF1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8456" y="381621"/>
            <a:ext cx="6464300" cy="528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21042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</TotalTime>
  <Words>92</Words>
  <Application>Microsoft Macintosh PowerPoint</Application>
  <PresentationFormat>Grand écran</PresentationFormat>
  <Paragraphs>16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9</cp:revision>
  <dcterms:created xsi:type="dcterms:W3CDTF">2023-08-09T07:55:48Z</dcterms:created>
  <dcterms:modified xsi:type="dcterms:W3CDTF">2024-01-05T09:55:48Z</dcterms:modified>
</cp:coreProperties>
</file>